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6858000" cy="9144000" type="screen4x3"/>
  <p:notesSz cx="666908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" initials="B" lastIdx="1" clrIdx="0"/>
  <p:cmAuthor id="1" name="Tuchscherr de Hauschopp, Lorena" initials="TdHL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8266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7710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2143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1375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3803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247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669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7399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9074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395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8550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7722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436" y="1043608"/>
            <a:ext cx="3043238" cy="2486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5836" y="1079233"/>
            <a:ext cx="2871788" cy="24788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feld 1"/>
          <p:cNvSpPr txBox="1"/>
          <p:nvPr/>
        </p:nvSpPr>
        <p:spPr>
          <a:xfrm>
            <a:off x="260649" y="251520"/>
            <a:ext cx="64087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Supporting Information Fig. 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S3: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I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nflammatory effects of SH1000 and mutants on osteoblasts 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350838" y="827584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itchFamily="34" charset="0"/>
                <a:cs typeface="Arial" pitchFamily="34" charset="0"/>
              </a:rPr>
              <a:t>A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991684" y="1251606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3059437" y="2587474"/>
            <a:ext cx="2551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5090346" y="1479769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*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789814" y="827584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itchFamily="34" charset="0"/>
                <a:cs typeface="Arial" pitchFamily="34" charset="0"/>
              </a:rPr>
              <a:t>B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Gruppieren 4"/>
          <p:cNvGrpSpPr/>
          <p:nvPr/>
        </p:nvGrpSpPr>
        <p:grpSpPr>
          <a:xfrm>
            <a:off x="360060" y="3491880"/>
            <a:ext cx="6093276" cy="2716320"/>
            <a:chOff x="360060" y="3491880"/>
            <a:chExt cx="6093276" cy="2716320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4000" y="3693600"/>
              <a:ext cx="2757488" cy="2514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5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95848" y="3693725"/>
              <a:ext cx="2757488" cy="237886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7" name="Textfeld 56"/>
            <p:cNvSpPr txBox="1"/>
            <p:nvPr/>
          </p:nvSpPr>
          <p:spPr>
            <a:xfrm>
              <a:off x="1248264" y="3533829"/>
              <a:ext cx="19159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steoblasts</a:t>
              </a:r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umans</a:t>
              </a:r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 LS1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feld 57"/>
            <p:cNvSpPr txBox="1"/>
            <p:nvPr/>
          </p:nvSpPr>
          <p:spPr>
            <a:xfrm>
              <a:off x="2288419" y="4512403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Textfeld 58"/>
            <p:cNvSpPr txBox="1"/>
            <p:nvPr/>
          </p:nvSpPr>
          <p:spPr>
            <a:xfrm>
              <a:off x="2493241" y="4431989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2920850" y="4483494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Textfeld 60"/>
            <p:cNvSpPr txBox="1"/>
            <p:nvPr/>
          </p:nvSpPr>
          <p:spPr>
            <a:xfrm>
              <a:off x="3136116" y="4479489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Textfeld 61"/>
            <p:cNvSpPr txBox="1"/>
            <p:nvPr/>
          </p:nvSpPr>
          <p:spPr>
            <a:xfrm>
              <a:off x="4877486" y="3909381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feld 62"/>
            <p:cNvSpPr txBox="1"/>
            <p:nvPr/>
          </p:nvSpPr>
          <p:spPr>
            <a:xfrm>
              <a:off x="5787566" y="4412679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feld 63"/>
            <p:cNvSpPr txBox="1"/>
            <p:nvPr/>
          </p:nvSpPr>
          <p:spPr>
            <a:xfrm>
              <a:off x="6094341" y="4600704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Textfeld 64"/>
            <p:cNvSpPr txBox="1"/>
            <p:nvPr/>
          </p:nvSpPr>
          <p:spPr>
            <a:xfrm>
              <a:off x="360060" y="3491880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Textfeld 65"/>
            <p:cNvSpPr txBox="1"/>
            <p:nvPr/>
          </p:nvSpPr>
          <p:spPr>
            <a:xfrm>
              <a:off x="3799036" y="3491880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Textfeld 66"/>
            <p:cNvSpPr txBox="1"/>
            <p:nvPr/>
          </p:nvSpPr>
          <p:spPr>
            <a:xfrm>
              <a:off x="4249395" y="3537466"/>
              <a:ext cx="216758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steoblasts</a:t>
              </a:r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umans</a:t>
              </a:r>
              <a:r>
                <a:rPr lang="de-DE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 SH1000</a:t>
              </a:r>
              <a:endParaRPr lang="de-DE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2693141" y="4584389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5112928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</Words>
  <Application>Microsoft Office PowerPoint</Application>
  <PresentationFormat>Bildschirmpräsentation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uchscherr de Hauschopp, Lorena</dc:creator>
  <cp:lastModifiedBy>Tuchscherr de Hauschopp, Lorena</cp:lastModifiedBy>
  <cp:revision>74</cp:revision>
  <cp:lastPrinted>2015-02-05T15:03:15Z</cp:lastPrinted>
  <dcterms:created xsi:type="dcterms:W3CDTF">2014-11-04T10:41:58Z</dcterms:created>
  <dcterms:modified xsi:type="dcterms:W3CDTF">2015-04-13T07:29:05Z</dcterms:modified>
</cp:coreProperties>
</file>